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DE59BEB-FDA7-400E-8B09-FF70AB355FC4}" v="2" dt="2024-05-08T17:25:19.8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94"/>
    <p:restoredTop sz="94711"/>
  </p:normalViewPr>
  <p:slideViewPr>
    <p:cSldViewPr snapToGrid="0">
      <p:cViewPr varScale="1">
        <p:scale>
          <a:sx n="85" d="100"/>
          <a:sy n="85" d="100"/>
        </p:scale>
        <p:origin x="9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anko Stefanovic" userId="09f315c5-de40-4db0-b16c-69b849528b6b" providerId="ADAL" clId="{9DE59BEB-FDA7-400E-8B09-FF70AB355FC4}"/>
    <pc:docChg chg="custSel modSld">
      <pc:chgData name="Branko Stefanovic" userId="09f315c5-de40-4db0-b16c-69b849528b6b" providerId="ADAL" clId="{9DE59BEB-FDA7-400E-8B09-FF70AB355FC4}" dt="2024-05-08T17:26:00.693" v="90" actId="1035"/>
      <pc:docMkLst>
        <pc:docMk/>
      </pc:docMkLst>
      <pc:sldChg chg="addSp delSp modSp mod">
        <pc:chgData name="Branko Stefanovic" userId="09f315c5-de40-4db0-b16c-69b849528b6b" providerId="ADAL" clId="{9DE59BEB-FDA7-400E-8B09-FF70AB355FC4}" dt="2024-05-08T17:26:00.693" v="90" actId="1035"/>
        <pc:sldMkLst>
          <pc:docMk/>
          <pc:sldMk cId="2486113480" sldId="257"/>
        </pc:sldMkLst>
        <pc:spChg chg="add del mod">
          <ac:chgData name="Branko Stefanovic" userId="09f315c5-de40-4db0-b16c-69b849528b6b" providerId="ADAL" clId="{9DE59BEB-FDA7-400E-8B09-FF70AB355FC4}" dt="2024-05-08T17:25:15.629" v="2"/>
          <ac:spMkLst>
            <pc:docMk/>
            <pc:sldMk cId="2486113480" sldId="257"/>
            <ac:spMk id="2" creationId="{A988EF22-35CE-1B7A-A31F-9A54209A215F}"/>
          </ac:spMkLst>
        </pc:spChg>
        <pc:spChg chg="add mod">
          <ac:chgData name="Branko Stefanovic" userId="09f315c5-de40-4db0-b16c-69b849528b6b" providerId="ADAL" clId="{9DE59BEB-FDA7-400E-8B09-FF70AB355FC4}" dt="2024-05-08T17:26:00.693" v="90" actId="1035"/>
          <ac:spMkLst>
            <pc:docMk/>
            <pc:sldMk cId="2486113480" sldId="257"/>
            <ac:spMk id="3" creationId="{FDD6B72B-F66E-0E1B-32DF-3875335CA5E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1A3A12-90BA-1991-74C9-C3D440FA6C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79F97F-BC79-D7B1-2D87-67CEF797A8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7190A-6EEF-F24D-D2ED-482B7DF5D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8DBBB9-1D98-724C-788B-A4312619D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FB37CC-33FD-3CE6-8EBD-12B36453E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05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CB407-C67D-12CE-60A2-5EC971925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DCB484-EFBB-D10D-6D38-B23A340E6C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F2527B-F6EE-51C1-35E6-E230B2E02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7BF4EF-CB58-B9F4-D961-03F0C578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0E9C4C-C27A-680E-5B6F-FBAF38B5C6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088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D874EA-B242-2612-E06C-5B73AAF9B4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0D2BE9-32C0-4429-4FA1-7D1599C356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5040E4-5E74-5306-DD82-FE96933D4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E3888C-35BF-59F8-3007-472B5A56E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74824B-31FA-B722-A2F5-0D8896C66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434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B9A25A-3C16-845F-A2BB-02E64B583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78470C-4FD5-3C6B-977E-981ACBC7CC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420C9-9600-FAD5-C849-00EA074A5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451BEE-89CC-400B-5F7B-3E5DB7D73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3EF9E6-7614-4CE8-1ACD-A6E09E337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05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31408-9C2E-6FD7-E9FD-DF5456089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81026A-D446-F862-6102-52C502FF72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55240C-2646-DDFB-A226-C808D99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F591A9-4EB6-F7FF-9AE2-8001AE12F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699AE5-9252-DEC5-1C52-C0A912E1B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716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C1E96-28A9-8F58-42D7-D40019AA1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293BE5-0E0D-C4DB-2A96-D9FB10AF5B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545EBC-8C16-8152-8014-AB4EA6EF84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498A9E-1E51-F0CC-8992-4760A7F74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7F77C5-BB88-B3D9-55B0-206AA666E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8A1486-89F7-3199-46FA-989B8C8D5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037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81CC4-3419-5FC9-D597-E924A5B6C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30C0BF-DCA0-D1B8-0958-D9A48F1130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939CC1-CB1C-192B-00CC-9AC88049FF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5E8029-2E08-B7C5-6BD0-C0682A4EB5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959517-D36A-FBB0-2263-2C2BB8AC96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948FC49-6118-0635-5E19-F475E6E4E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5E63F1-36C5-9FE3-137B-B7E5FD2B8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005246-6795-58AD-9830-532E63AF3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7441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A218D4-17B8-D414-727F-784FC80CF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D454E7-B6AE-2B79-47A7-7DBDE8E40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AF37EB-CE4B-AAEC-5EA6-CCC1AF08C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4EA278-94E3-D4CF-721B-ABDA2A25A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43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D93C0A-497C-4AF6-9DB1-5C2C60AA2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230598-E3AB-1B3E-28D8-E4B33F063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B95C8C-5210-717F-64C0-78AFD785F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28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228FE-CC46-3B1D-A3B9-544CE5B47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019EFD-391B-216E-B2C8-19FEEB528B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BA7AD4-CF44-C90C-F598-2297AF07CC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BD392D-659C-A20E-0D33-C338ADEF3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D66C8B-3617-CE17-6147-ECD0AE6F3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881B0F-F9B4-6849-AC51-789AAAE01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82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B4FAC0-5537-1608-2B4E-B882CF9430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9E0F8B-0A21-EA99-80A8-44E508A500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14AB29-9214-8B9C-8522-907F4BB035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54BC6-F4C8-32EA-962E-956CCF292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A18AF0-F530-5469-45F8-692FCCC12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3F5ADF-BBE6-6184-8768-EF29668BD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84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0368EB-411A-C7C1-67ED-31334BA4AF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E1132B-4BC6-ADD4-3C70-B234BFFC93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9452A-6F1F-28CF-5958-B748CEB54C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63756E-B80B-894A-9722-11CED7100719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E330F-287F-8244-D8D5-210DA7D764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E52EE-9BDA-4DEA-1A4E-9BFBB33C78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E299E4-1A23-BF40-A33A-B52449EDC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427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BACA1D1-24F5-C4D7-F85A-112D006A49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0796" y="1302025"/>
            <a:ext cx="2327445" cy="4491107"/>
          </a:xfrm>
          <a:prstGeom prst="rect">
            <a:avLst/>
          </a:prstGeom>
        </p:spPr>
      </p:pic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E7AF9FF8-F7B8-C4C3-4EDE-A2683EA93D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6002670"/>
              </p:ext>
            </p:extLst>
          </p:nvPr>
        </p:nvGraphicFramePr>
        <p:xfrm>
          <a:off x="4234897" y="1675993"/>
          <a:ext cx="7682120" cy="1133475"/>
        </p:xfrm>
        <a:graphic>
          <a:graphicData uri="http://schemas.openxmlformats.org/drawingml/2006/table">
            <a:tbl>
              <a:tblPr/>
              <a:tblGrid>
                <a:gridCol w="2215808">
                  <a:extLst>
                    <a:ext uri="{9D8B030D-6E8A-4147-A177-3AD203B41FA5}">
                      <a16:colId xmlns:a16="http://schemas.microsoft.com/office/drawing/2014/main" val="1876773687"/>
                    </a:ext>
                  </a:extLst>
                </a:gridCol>
                <a:gridCol w="976127">
                  <a:extLst>
                    <a:ext uri="{9D8B030D-6E8A-4147-A177-3AD203B41FA5}">
                      <a16:colId xmlns:a16="http://schemas.microsoft.com/office/drawing/2014/main" val="103551820"/>
                    </a:ext>
                  </a:extLst>
                </a:gridCol>
                <a:gridCol w="1151830">
                  <a:extLst>
                    <a:ext uri="{9D8B030D-6E8A-4147-A177-3AD203B41FA5}">
                      <a16:colId xmlns:a16="http://schemas.microsoft.com/office/drawing/2014/main" val="2302430107"/>
                    </a:ext>
                  </a:extLst>
                </a:gridCol>
                <a:gridCol w="1200637">
                  <a:extLst>
                    <a:ext uri="{9D8B030D-6E8A-4147-A177-3AD203B41FA5}">
                      <a16:colId xmlns:a16="http://schemas.microsoft.com/office/drawing/2014/main" val="911107026"/>
                    </a:ext>
                  </a:extLst>
                </a:gridCol>
                <a:gridCol w="976127">
                  <a:extLst>
                    <a:ext uri="{9D8B030D-6E8A-4147-A177-3AD203B41FA5}">
                      <a16:colId xmlns:a16="http://schemas.microsoft.com/office/drawing/2014/main" val="4226141454"/>
                    </a:ext>
                  </a:extLst>
                </a:gridCol>
                <a:gridCol w="1161591">
                  <a:extLst>
                    <a:ext uri="{9D8B030D-6E8A-4147-A177-3AD203B41FA5}">
                      <a16:colId xmlns:a16="http://schemas.microsoft.com/office/drawing/2014/main" val="42155249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Tukey's multiple comparisons te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Mean Diff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5.00% CI of diff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elow threshold?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ummar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Adjusted P Valu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84943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Cl4+EtOH vs. CCl4+EtOH+FK5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6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620 to 6.6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08136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Cl4+EtOH vs. FK5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9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945 to 6.9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252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Cl4+EtOH vs. C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8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747 to 6.8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&lt;0.0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97779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CCl4+EtOH+FK506 vs. FK5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2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-1.674 to 2.3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7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13026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Cl4+EtOH+FK506 vs. C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19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-1.872 to 2.2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9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77664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K506 vs. C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-0.12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-2.198 to 1.9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99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053329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DD6B72B-F66E-0E1B-32DF-3875335CA5E5}"/>
              </a:ext>
            </a:extLst>
          </p:cNvPr>
          <p:cNvSpPr txBox="1"/>
          <p:nvPr/>
        </p:nvSpPr>
        <p:spPr>
          <a:xfrm>
            <a:off x="4255910" y="3081864"/>
            <a:ext cx="13997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rror bars: +-1SEM</a:t>
            </a:r>
          </a:p>
        </p:txBody>
      </p:sp>
    </p:spTree>
    <p:extLst>
      <p:ext uri="{BB962C8B-B14F-4D97-AF65-F5344CB8AC3E}">
        <p14:creationId xmlns:p14="http://schemas.microsoft.com/office/powerpoint/2010/main" val="2486113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16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tefanovic, Branko</cp:lastModifiedBy>
  <cp:revision>4</cp:revision>
  <dcterms:created xsi:type="dcterms:W3CDTF">2024-05-07T17:06:31Z</dcterms:created>
  <dcterms:modified xsi:type="dcterms:W3CDTF">2024-05-08T17:26:10Z</dcterms:modified>
</cp:coreProperties>
</file>